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90" d="100"/>
          <a:sy n="90" d="100"/>
        </p:scale>
        <p:origin x="-116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9621D3-F871-4F21-B11F-A51E035B8897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F78892-D1F0-4A25-BB5B-8A5CA46A0D5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940957" y="1353982"/>
            <a:ext cx="4896544" cy="265876"/>
          </a:xfrm>
        </p:spPr>
        <p:txBody>
          <a:bodyPr>
            <a:noAutofit/>
          </a:bodyPr>
          <a:lstStyle/>
          <a:p>
            <a:pPr>
              <a:buNone/>
            </a:pPr>
            <a:r>
              <a:rPr lang="en-US" sz="800" b="1" dirty="0" smtClean="0">
                <a:latin typeface="Arial" pitchFamily="34" charset="0"/>
                <a:cs typeface="Arial" pitchFamily="34" charset="0"/>
              </a:rPr>
              <a:t>Table S7 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Primer sequences of </a:t>
            </a:r>
            <a:r>
              <a:rPr lang="en-US" sz="800" i="1" dirty="0" smtClean="0">
                <a:latin typeface="Arial" pitchFamily="34" charset="0"/>
                <a:cs typeface="Arial" pitchFamily="34" charset="0"/>
              </a:rPr>
              <a:t>GmaPHO1 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genes used in the present work.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/>
        </p:nvGraphicFramePr>
        <p:xfrm>
          <a:off x="922717" y="1607768"/>
          <a:ext cx="5018900" cy="4181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08112"/>
                <a:gridCol w="1656184"/>
                <a:gridCol w="1728192"/>
                <a:gridCol w="626412"/>
              </a:tblGrid>
              <a:tr h="15307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dirty="0" smtClean="0">
                          <a:latin typeface="Arial" pitchFamily="34" charset="0"/>
                          <a:cs typeface="Arial" pitchFamily="34" charset="0"/>
                        </a:rPr>
                        <a:t>Gene</a:t>
                      </a:r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dirty="0" smtClean="0">
                          <a:latin typeface="Arial" pitchFamily="34" charset="0"/>
                          <a:cs typeface="Arial" pitchFamily="34" charset="0"/>
                        </a:rPr>
                        <a:t>Forward</a:t>
                      </a:r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dirty="0" smtClean="0">
                          <a:latin typeface="Arial" pitchFamily="34" charset="0"/>
                          <a:cs typeface="Arial" pitchFamily="34" charset="0"/>
                        </a:rPr>
                        <a:t>Reverse</a:t>
                      </a:r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dirty="0" smtClean="0">
                          <a:latin typeface="Arial" pitchFamily="34" charset="0"/>
                          <a:cs typeface="Arial" pitchFamily="34" charset="0"/>
                        </a:rPr>
                        <a:t>Usage</a:t>
                      </a:r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07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1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ATGGTGAAATTCTCAAAGGAGC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TTTCAGCGAATTCATAGGACA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12">
                  <a:txBody>
                    <a:bodyPr/>
                    <a:lstStyle/>
                    <a:p>
                      <a:pPr algn="ctr"/>
                      <a:r>
                        <a:rPr lang="en-US" altLang="zh-CN" sz="700" dirty="0" err="1" smtClean="0">
                          <a:latin typeface="Arial" pitchFamily="34" charset="0"/>
                          <a:cs typeface="Arial" pitchFamily="34" charset="0"/>
                        </a:rPr>
                        <a:t>cDNA</a:t>
                      </a:r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 amplification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07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2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TTTCCAAATACCAAAGAGGCTGCT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AGATTCTTGTTGTTCTGTGCTTGC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 vMerge="1">
                  <a:txBody>
                    <a:bodyPr/>
                    <a:lstStyle/>
                    <a:p>
                      <a:pPr algn="l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3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ATGAAGTTTGGGAAAGAATTTG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CTTTCTTCAAGCAAACGTCGAA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 vMerge="1">
                  <a:txBody>
                    <a:bodyPr/>
                    <a:lstStyle/>
                    <a:p>
                      <a:pPr algn="l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4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CAACACAAAACCAAACCAAAAATG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GAGAAAATCACCTCAGCTGTCTGAG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 vMerge="1">
                  <a:txBody>
                    <a:bodyPr/>
                    <a:lstStyle/>
                    <a:p>
                      <a:pPr algn="l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5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CTCTCTTCACCTCCAGGCTCCT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ACAGATTAAGCGAAGTTTCTATCC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 vMerge="1">
                  <a:txBody>
                    <a:bodyPr/>
                    <a:lstStyle/>
                    <a:p>
                      <a:pPr algn="l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6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CATGTGTCTCACTCGAAAAAAAGAA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CAAGAGAGTGGGTTATTACAGTTT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 vMerge="1">
                  <a:txBody>
                    <a:bodyPr/>
                    <a:lstStyle/>
                    <a:p>
                      <a:pPr algn="l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7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AATACCAGAGAGGCTACAAGGGTC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ATGTTGAAGTCCAATAATAATGAG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 vMerge="1">
                  <a:txBody>
                    <a:bodyPr/>
                    <a:lstStyle/>
                    <a:p>
                      <a:pPr algn="l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8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ACAACACAACACCTATCACTCTTC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TCTTTACACTCCATGCCTCTATTT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 vMerge="1">
                  <a:txBody>
                    <a:bodyPr/>
                    <a:lstStyle/>
                    <a:p>
                      <a:pPr algn="l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9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ATGAAGTTTGGGAAAGAATACA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GAAAGAATAAAAGAAGGAGCGA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 vMerge="1">
                  <a:txBody>
                    <a:bodyPr/>
                    <a:lstStyle/>
                    <a:p>
                      <a:pPr algn="l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10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ATGAAGTTTGGGAAAGAATACA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TCACTCCTCTTTATCTTCGTCT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 vMerge="1">
                  <a:txBody>
                    <a:bodyPr/>
                    <a:lstStyle/>
                    <a:p>
                      <a:pPr algn="l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12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TCTCAAAAAGCATTCACACG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AGCCTAGTATCACGTCAATCATC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  <a:tc vMerge="1">
                  <a:txBody>
                    <a:bodyPr/>
                    <a:lstStyle/>
                    <a:p>
                      <a:pPr algn="l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14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CGCATTCACAAGGCATCACCTA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CTACCCTCGAATAAATCACCCA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6000" marB="36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077">
                <a:tc>
                  <a:txBody>
                    <a:bodyPr/>
                    <a:lstStyle/>
                    <a:p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1/H4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CAACACAAAACCAAACCAAAAATG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TCTTATGAAGCGAAACGAATC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10"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Real-time </a:t>
                      </a:r>
                    </a:p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RT-PCR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077">
                <a:tc>
                  <a:txBody>
                    <a:bodyPr/>
                    <a:lstStyle/>
                    <a:p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2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TTTCCAAATACCAAAGAGGCTGCT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TGGTAGTATCTGTGTGTGAGG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 vMerge="1">
                  <a:txBody>
                    <a:bodyPr/>
                    <a:lstStyle/>
                    <a:p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3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TATGTGGGAATGAGGAGGAGG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TGATCTAGGCAAAATTGGGTGT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 vMerge="1">
                  <a:txBody>
                    <a:bodyPr/>
                    <a:lstStyle/>
                    <a:p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5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CTCTCTTCACCTCCAGGCTCCT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CTGGTATCAGTTGGGCTTCTA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 vMerge="1">
                  <a:txBody>
                    <a:bodyPr/>
                    <a:lstStyle/>
                    <a:p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6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TATGTGGGAATGAGGAGGAGG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CAAGAGAGTGGGTTATTACAGTTT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 vMerge="1">
                  <a:txBody>
                    <a:bodyPr/>
                    <a:lstStyle/>
                    <a:p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7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TGATTGGCAGGAACAGAAATT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ATGTTGAAGTCCAATAATAATGAG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 vMerge="1">
                  <a:txBody>
                    <a:bodyPr/>
                    <a:lstStyle/>
                    <a:p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8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TTTCCTCTACACAACACAACACCT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GGCCTCTTTCCATTCTGGTATC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 vMerge="1">
                  <a:txBody>
                    <a:bodyPr/>
                    <a:lstStyle/>
                    <a:p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GmaPHO1;H9/10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ATGAAGTTTGGGAAAGAATACA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TTGAAGTACACCAACTCGTATT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 vMerge="1">
                  <a:txBody>
                    <a:bodyPr/>
                    <a:lstStyle/>
                    <a:p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</a:tr>
              <a:tr h="153077">
                <a:tc>
                  <a:txBody>
                    <a:bodyPr/>
                    <a:lstStyle/>
                    <a:p>
                      <a:r>
                        <a:rPr lang="en-US" altLang="zh-CN" sz="700" b="1" i="1" smtClean="0">
                          <a:latin typeface="Arial" pitchFamily="34" charset="0"/>
                          <a:cs typeface="Arial" pitchFamily="34" charset="0"/>
                        </a:rPr>
                        <a:t>GmaPHO1;H12/H14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CAACAACATTCACCTAAACA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ACTTCGTCGGCTAACTTCATC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  <a:tc vMerge="1">
                  <a:txBody>
                    <a:bodyPr/>
                    <a:lstStyle/>
                    <a:p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/>
                </a:tc>
              </a:tr>
              <a:tr h="108696">
                <a:tc>
                  <a:txBody>
                    <a:bodyPr/>
                    <a:lstStyle/>
                    <a:p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Actin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ATCTTGACTGAGCGTGGTTATTCC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GCTGGTCCTGGCTGTCTCC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600" marB="396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0</TotalTime>
  <Words>87</Words>
  <Application>Microsoft Office PowerPoint</Application>
  <PresentationFormat>全屏显示(4:3)</PresentationFormat>
  <Paragraphs>7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unknown</dc:creator>
  <cp:lastModifiedBy>unknown</cp:lastModifiedBy>
  <cp:revision>192</cp:revision>
  <dcterms:created xsi:type="dcterms:W3CDTF">2012-12-26T01:47:15Z</dcterms:created>
  <dcterms:modified xsi:type="dcterms:W3CDTF">2013-05-21T07:08:09Z</dcterms:modified>
</cp:coreProperties>
</file>